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>
      <p:cViewPr varScale="1">
        <p:scale>
          <a:sx n="121" d="100"/>
          <a:sy n="121" d="100"/>
        </p:scale>
        <p:origin x="1904" y="17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6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6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6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6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6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6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2/1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picture containing text, black, indoor, orange&#10;&#10;Description automatically generated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0200" y="622618"/>
            <a:ext cx="5562600" cy="5252972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228600" y="5934670"/>
            <a:ext cx="838200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Figure S1. </a:t>
            </a:r>
            <a:r>
              <a:rPr lang="en-US" i="1" dirty="0">
                <a:latin typeface="Times New Roman" pitchFamily="18" charset="0"/>
                <a:cs typeface="Times New Roman" pitchFamily="18" charset="0"/>
              </a:rPr>
              <a:t>M. smegmatis atr9c 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with tested compounds and the antimicrobial </a:t>
            </a:r>
            <a:r>
              <a:rPr lang="en-US" b="1" dirty="0">
                <a:latin typeface="Times New Roman" pitchFamily="18" charset="0"/>
                <a:cs typeface="Times New Roman" pitchFamily="18" charset="0"/>
              </a:rPr>
              <a:t>3a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. Compounds </a:t>
            </a:r>
            <a:r>
              <a:rPr lang="en-US" dirty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BDE </a:t>
            </a:r>
            <a:r>
              <a:rPr lang="en-US" dirty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26593610 (BDE26), BDD 27860195 (BDD27) and BDF 33196400 (BDF33) were applied at 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50 nmol/disc</a:t>
            </a:r>
            <a:r>
              <a:rPr lang="en-US" dirty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, while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b="1" dirty="0">
                <a:latin typeface="Times New Roman" pitchFamily="18" charset="0"/>
                <a:cs typeface="Times New Roman" pitchFamily="18" charset="0"/>
              </a:rPr>
              <a:t>3a 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at</a:t>
            </a:r>
            <a:r>
              <a:rPr lang="en-US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400 nmol/disc </a:t>
            </a:r>
            <a:r>
              <a:rPr lang="en-US" b="1" dirty="0">
                <a:latin typeface="Times New Roman" pitchFamily="18" charset="0"/>
                <a:cs typeface="Times New Roman" pitchFamily="18" charset="0"/>
              </a:rPr>
              <a:t>.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picture containing text, road, black&#10;&#10;Description automatically generated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28600"/>
            <a:ext cx="6553200" cy="6248400"/>
          </a:xfrm>
          <a:prstGeom prst="rect">
            <a:avLst/>
          </a:prstGeom>
        </p:spPr>
      </p:pic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6553200" y="2017930"/>
            <a:ext cx="2590800" cy="28931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kumimoji="0" lang="en-US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Figure S2. </a:t>
            </a:r>
            <a:r>
              <a:rPr kumimoji="0" 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Growth inhibition halos produced by MmpS5-MmpL5 inhibitors and tryptanthrins on </a:t>
            </a:r>
            <a:r>
              <a:rPr kumimoji="0" lang="en-US" sz="14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M. smegmatis strains</a:t>
            </a:r>
            <a:r>
              <a:rPr kumimoji="0" 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. The compound </a:t>
            </a:r>
            <a:r>
              <a:rPr kumimoji="0" lang="en-US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lables</a:t>
            </a:r>
            <a:r>
              <a:rPr kumimoji="0" 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represent the following: </a:t>
            </a:r>
            <a:r>
              <a:rPr lang="en-US" sz="1400" dirty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BDE26  - </a:t>
            </a:r>
            <a:r>
              <a:rPr kumimoji="0" 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BDE </a:t>
            </a:r>
            <a:r>
              <a:rPr kumimoji="0" lang="en-US" sz="14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26593610, 50 nmol/disc</a:t>
            </a:r>
            <a:r>
              <a:rPr lang="en-US" sz="1400" dirty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; BDD27 - </a:t>
            </a:r>
            <a:r>
              <a:rPr kumimoji="0" lang="en-US" sz="14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BDD 27860195, 50 nmol/disc);</a:t>
            </a:r>
            <a:r>
              <a:rPr kumimoji="0" 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TRP – tryptanthrin, 30 nmol/disc; PK31 - 8-fluorotryptanthrin, 10 nmol/disc. </a:t>
            </a:r>
            <a:r>
              <a:rPr kumimoji="0" lang="en-US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(</a:t>
            </a:r>
            <a:r>
              <a:rPr kumimoji="0" 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A, C) </a:t>
            </a:r>
            <a:r>
              <a:rPr kumimoji="0" lang="en-US" sz="14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M. smegmatis mc2</a:t>
            </a:r>
            <a:r>
              <a:rPr kumimoji="0" lang="en-US" sz="14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/>
                <a:ea typeface="Times New Roman" pitchFamily="18" charset="0"/>
                <a:cs typeface="Times New Roman" pitchFamily="18" charset="0"/>
              </a:rPr>
              <a:t> </a:t>
            </a:r>
            <a:r>
              <a:rPr kumimoji="0" lang="en-US" sz="14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155</a:t>
            </a:r>
            <a:r>
              <a:rPr kumimoji="0" 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; (B, D) </a:t>
            </a:r>
            <a:r>
              <a:rPr kumimoji="0" lang="en-US" sz="14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M. smegmatis atr9c</a:t>
            </a:r>
            <a:r>
              <a:rPr kumimoji="0" 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.</a:t>
            </a:r>
            <a:endParaRPr kumimoji="0" lang="en-US" sz="2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132</Words>
  <Application>Microsoft Macintosh PowerPoint</Application>
  <PresentationFormat>On-screen Show (4:3)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shah</dc:creator>
  <cp:lastModifiedBy>Dmitry Maslov</cp:lastModifiedBy>
  <cp:revision>3</cp:revision>
  <dcterms:created xsi:type="dcterms:W3CDTF">2006-08-16T00:00:00Z</dcterms:created>
  <dcterms:modified xsi:type="dcterms:W3CDTF">2021-12-16T12:47:50Z</dcterms:modified>
</cp:coreProperties>
</file>